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9144000" cy="6858000" type="screen4x3"/>
  <p:notesSz cx="6858000" cy="9144000"/>
  <p:custDataLst>
    <p:tags r:id="rId4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FF"/>
    <a:srgbClr val="008000"/>
    <a:srgbClr val="996600"/>
    <a:srgbClr val="006600"/>
    <a:srgbClr val="990099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 autoAdjust="0"/>
    <p:restoredTop sz="94585" autoAdjust="0"/>
  </p:normalViewPr>
  <p:slideViewPr>
    <p:cSldViewPr snapToGrid="0">
      <p:cViewPr>
        <p:scale>
          <a:sx n="80" d="100"/>
          <a:sy n="80" d="100"/>
        </p:scale>
        <p:origin x="-912" y="-5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>
      <p:cViewPr varScale="1">
        <p:scale>
          <a:sx n="82" d="100"/>
          <a:sy n="82" d="100"/>
        </p:scale>
        <p:origin x="-3936" y="-96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4A0EE6-1AEB-4320-B071-D9A4A03B3ED2}" type="datetimeFigureOut">
              <a:rPr lang="en-US" smtClean="0"/>
              <a:pPr/>
              <a:t>6/11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0A0E9E-2ACA-44AD-BEF1-031FA851C0D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0109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F9E469-D60F-4038-B20E-723A0D3FB216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6B4CF4-3EC9-4213-A168-B5FF11E57DE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4EF24E-8986-4213-878A-B70333F0BDF7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7FF9A3-B42B-4301-8C30-D0E7772DBAB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94077C-1FC4-4B66-9434-D9D2F68D1A53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39DDA8-9250-472A-B0AD-28FCB24525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9F89D9-F6B2-49C8-8600-62354FA59D01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608677-5349-42D8-A5EC-1DD6F1E7309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8B91F1-F8B8-42D4-96AC-01D5829B989D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5383A1-6872-4BDD-A0CA-8E5E7D54B27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7B64BF-A1DF-44DC-BB50-5C1B31AADA9E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082968-46A5-49FB-843B-968C60F7B8A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863F39-56A7-4BDD-9BDF-CE2ED9617389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3D7A67-603A-4443-B981-FED77F8B8BC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72829A-F9AD-4F85-8742-A7921280B491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E9FB66-E665-4ECA-B3BF-6757A74945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9B7FD3-B99E-4187-9933-AC9AB1DB312E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EA5B27-D46A-45E5-997E-51E74B173BE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536B44-95B8-4C0A-995D-B6DA89033923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5727CC-AEDC-4499-97F7-F71B072ABA4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E4FE53-0901-46B4-BB33-B6E688B1B947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47EBED-B686-4F5E-AA92-8267F9708D3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614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1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1D707B30-B607-4830-AF03-751890073B6C}" type="datetimeFigureOut">
              <a:rPr lang="en-US"/>
              <a:pPr>
                <a:defRPr/>
              </a:pPr>
              <a:t>6/11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753FBA08-8B6C-4D0B-A2C0-C870076B75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ictureTable1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89703" y="249375"/>
            <a:ext cx="7216146" cy="3523274"/>
          </a:xfrm>
          <a:prstGeom prst="rect">
            <a:avLst/>
          </a:prstGeom>
        </p:spPr>
      </p:pic>
      <p:pic>
        <p:nvPicPr>
          <p:cNvPr id="5" name="Picture 4" descr="PictureTable1B.pn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134974" y="3895106"/>
            <a:ext cx="6925603" cy="1870648"/>
          </a:xfrm>
          <a:prstGeom prst="rect">
            <a:avLst/>
          </a:prstGeom>
        </p:spPr>
      </p:pic>
      <p:sp>
        <p:nvSpPr>
          <p:cNvPr id="8" name="Rectangle 7"/>
          <p:cNvSpPr>
            <a:spLocks noChangeArrowheads="1"/>
          </p:cNvSpPr>
          <p:nvPr/>
        </p:nvSpPr>
        <p:spPr bwMode="auto">
          <a:xfrm>
            <a:off x="444875" y="5904017"/>
            <a:ext cx="8305800" cy="707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000" b="1" smtClean="0">
                <a:latin typeface="Arial" pitchFamily="34" charset="0"/>
                <a:cs typeface="Arial" pitchFamily="34" charset="0"/>
              </a:rPr>
              <a:t>Additional file </a:t>
            </a:r>
            <a:r>
              <a:rPr lang="en-US" sz="1000" b="1" smtClean="0">
                <a:latin typeface="Arial" pitchFamily="34" charset="0"/>
                <a:cs typeface="Arial" pitchFamily="34" charset="0"/>
              </a:rPr>
              <a:t>9: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Querying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for the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expression  fold change  between early and late seed developmental stages in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a subset of rice genes  using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PathVisio. (A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)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Results obtained after statistical analysis with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user-defined criteria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to identify genes with very high expression in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the desiccation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stage of seed development in 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rice. (B) </a:t>
            </a:r>
            <a:r>
              <a:rPr lang="en-US" sz="1000" dirty="0">
                <a:solidFill>
                  <a:srgbClr val="000000"/>
                </a:solidFill>
                <a:latin typeface="Arial" pitchFamily="34" charset="0"/>
                <a:ea typeface="Calibri" pitchFamily="34" charset="0"/>
                <a:cs typeface="Arial" pitchFamily="34" charset="0"/>
              </a:rPr>
              <a:t>Combined table showing different criteria used to query rice seed gene expression data and the results obtained. 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39382" y="29689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430534" y="384760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510343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7.0&quot;&gt;&lt;object type=&quot;1&quot; unique_id=&quot;10001&quot;&gt;&lt;object type=&quot;8&quot; unique_id=&quot;10002&quot;&gt;&lt;/object&gt;&lt;object type=&quot;2&quot; unique_id=&quot;10003&quot;&gt;&lt;object type=&quot;3&quot; unique_id=&quot;10026&quot;&gt;&lt;property id=&quot;20148&quot; value=&quot;5&quot;/&gt;&lt;property id=&quot;20300&quot; value=&quot;Slide 1&quot;/&gt;&lt;property id=&quot;20307&quot; value=&quot;284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pex</Template>
  <TotalTime>11381</TotalTime>
  <Words>77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Oregon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iswal Lab</dc:creator>
  <cp:lastModifiedBy>Real, Francis Frank</cp:lastModifiedBy>
  <cp:revision>542</cp:revision>
  <dcterms:created xsi:type="dcterms:W3CDTF">2012-03-13T21:10:20Z</dcterms:created>
  <dcterms:modified xsi:type="dcterms:W3CDTF">2013-06-11T10:46:00Z</dcterms:modified>
</cp:coreProperties>
</file>